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6419513" cy="108172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A046F-D29F-4518-B18F-0EF6BDE803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147765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20800" y="6253560"/>
            <a:ext cx="147765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E752C-CC71-4967-9812-0C915CB973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839268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20800" y="625356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8392680" y="625356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47763-2974-43C5-B1A7-7377F91DB5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816880" y="252360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0812960" y="252360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20800" y="625356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816880" y="625356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0812960" y="6253560"/>
            <a:ext cx="47577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7DCA7-D63E-4FEA-8F3E-0FA910074A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20800" y="2523600"/>
            <a:ext cx="14776560" cy="714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12D77-1455-42F6-8DE8-3EB8134EEB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1477656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D5E46-3DD0-4E0E-9FAC-73F5C21506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721080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8392680" y="2523600"/>
            <a:ext cx="721080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3DBA4-B5A6-45DB-AABF-EAA6D08E7D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2B997-BAAA-4BD7-9B0E-9230310938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20800" y="433080"/>
            <a:ext cx="14776560" cy="8359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41C8E-911A-430A-9B96-D9FF27C25E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8392680" y="2523600"/>
            <a:ext cx="721080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20800" y="625356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6E4B0-ECA9-4207-9440-512E4EA131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721080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839268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8392680" y="625356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06588-D504-4EF4-954A-6FF074002D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2080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8392680" y="2523600"/>
            <a:ext cx="721080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20800" y="6253560"/>
            <a:ext cx="14776560" cy="3405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indent="0">
              <a:spcBef>
                <a:spcPts val="117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A44F4-D54A-44B2-B7B7-C7EEA5E166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20800" y="433080"/>
            <a:ext cx="14776560" cy="180324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6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20800" y="2523600"/>
            <a:ext cx="14776560" cy="714060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rmAutofit/>
          </a:bodyPr>
          <a:p>
            <a:pPr marL="506520" indent="-506520">
              <a:spcBef>
                <a:spcPts val="117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1" marL="1096920" indent="-420480">
              <a:spcBef>
                <a:spcPts val="117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2" marL="1687680" indent="-336600">
              <a:spcBef>
                <a:spcPts val="117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3" marL="2362320" indent="-336600">
              <a:spcBef>
                <a:spcPts val="117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4" marL="3038400" indent="-336600">
              <a:spcBef>
                <a:spcPts val="1176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5" marL="3038400" indent="-336600">
              <a:spcBef>
                <a:spcPts val="1176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  <a:p>
            <a:pPr lvl="6" marL="3038400" indent="-336600">
              <a:spcBef>
                <a:spcPts val="1176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20800" y="9852120"/>
            <a:ext cx="3830400" cy="750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5609880" y="9852120"/>
            <a:ext cx="5197320" cy="750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1766240" y="9852120"/>
            <a:ext cx="3830760" cy="750960"/>
          </a:xfrm>
          <a:prstGeom prst="rect">
            <a:avLst/>
          </a:prstGeom>
          <a:noFill/>
          <a:ln w="0">
            <a:noFill/>
          </a:ln>
        </p:spPr>
        <p:txBody>
          <a:bodyPr lIns="135000" rIns="135000" tIns="67680" bIns="676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a-ES" sz="2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2B6440-8871-4021-82CE-EBA110ABBF2A}" type="slidenum">
              <a:rPr b="0" lang="ca-ES" sz="2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720720" y="184320"/>
            <a:ext cx="14903280" cy="77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5000" rIns="135000" tIns="67680" bIns="676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Figure S1. Validation by RT-qPCR of the differential expression of mRNA isoforms corresponding to the </a:t>
            </a:r>
            <a:r>
              <a:rPr b="0" i="1" lang="en-GB" sz="2100" spc="-1" strike="noStrike">
                <a:solidFill>
                  <a:srgbClr val="000000"/>
                </a:solidFill>
                <a:latin typeface="Arial"/>
              </a:rPr>
              <a:t>RXRG</a:t>
            </a: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GB" sz="2100" spc="-1" strike="noStrike">
                <a:solidFill>
                  <a:srgbClr val="000000"/>
                </a:solidFill>
                <a:latin typeface="Arial"/>
              </a:rPr>
              <a:t>SCD</a:t>
            </a: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GB" sz="2100" spc="-1" strike="noStrike">
                <a:solidFill>
                  <a:srgbClr val="000000"/>
                </a:solidFill>
                <a:latin typeface="Arial"/>
              </a:rPr>
              <a:t>MAFF</a:t>
            </a: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GB" sz="2100" spc="-1" strike="noStrike">
                <a:solidFill>
                  <a:srgbClr val="000000"/>
                </a:solidFill>
                <a:latin typeface="Arial"/>
              </a:rPr>
              <a:t>ITGA5</a:t>
            </a: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 genes in HIGH </a:t>
            </a:r>
            <a:r>
              <a:rPr b="0" i="1" lang="en-GB" sz="21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GB" sz="2100" spc="-1" strike="noStrike">
                <a:solidFill>
                  <a:srgbClr val="000000"/>
                </a:solidFill>
                <a:latin typeface="Arial"/>
              </a:rPr>
              <a:t> LOW pigs</a:t>
            </a:r>
            <a:r>
              <a:rPr b="0" lang="ca-ES" sz="21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5 Imagen" descr="qPCR_new.png"/>
          <p:cNvPicPr/>
          <p:nvPr/>
        </p:nvPicPr>
        <p:blipFill>
          <a:blip r:embed="rId1"/>
          <a:stretch/>
        </p:blipFill>
        <p:spPr>
          <a:xfrm>
            <a:off x="1440000" y="2384280"/>
            <a:ext cx="14200200" cy="532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29T17:19:50Z</dcterms:created>
  <dc:creator>Universitat Autònoma de Barcelona</dc:creator>
  <dc:description/>
  <cp:keywords/>
  <dc:language>en-US</dc:language>
  <cp:lastModifiedBy>ma</cp:lastModifiedBy>
  <dcterms:modified xsi:type="dcterms:W3CDTF">2017-12-28T19:10:17Z</dcterms:modified>
  <cp:revision>11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3082-10.2.0.5820</vt:lpwstr>
  </property>
</Properties>
</file>